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5">
  <p:sldMasterIdLst>
    <p:sldMasterId id="2147483648" r:id="rId4"/>
  </p:sldMasterIdLst>
  <p:notesMasterIdLst>
    <p:notesMasterId r:id="rId6"/>
  </p:notesMasterIdLst>
  <p:sldIdLst>
    <p:sldId id="26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A31C418-18D7-FC01-4DB0-DB8C5F15C850}" name="Aziana Abu Hassan" initials="AAH" userId="Aziana Abu Hassan" providerId="None"/>
  <p188:author id="{307D5664-BCA0-BEA9-4FF5-496CF704CFAE}" name="Marko Hanzevacki (staff)" initials="MH(" userId="Marko Hanzevacki (staff)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E1EFA"/>
    <a:srgbClr val="FFA000"/>
    <a:srgbClr val="02FF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65" autoAdjust="0"/>
    <p:restoredTop sz="85830" autoAdjust="0"/>
  </p:normalViewPr>
  <p:slideViewPr>
    <p:cSldViewPr snapToGrid="0">
      <p:cViewPr varScale="1">
        <p:scale>
          <a:sx n="96" d="100"/>
          <a:sy n="96" d="100"/>
        </p:scale>
        <p:origin x="112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ca Pordea (staff)" userId="04217c9e-4602-4538-8d25-5638668eb9f5" providerId="ADAL" clId="{192F7D91-0ACB-412C-8994-807677E4477E}"/>
    <pc:docChg chg="delSld modSld">
      <pc:chgData name="Anca Pordea (staff)" userId="04217c9e-4602-4538-8d25-5638668eb9f5" providerId="ADAL" clId="{192F7D91-0ACB-412C-8994-807677E4477E}" dt="2023-12-19T19:16:03.391" v="12" actId="1036"/>
      <pc:docMkLst>
        <pc:docMk/>
      </pc:docMkLst>
      <pc:sldChg chg="del">
        <pc:chgData name="Anca Pordea (staff)" userId="04217c9e-4602-4538-8d25-5638668eb9f5" providerId="ADAL" clId="{192F7D91-0ACB-412C-8994-807677E4477E}" dt="2023-12-18T19:36:05.114" v="0" actId="47"/>
        <pc:sldMkLst>
          <pc:docMk/>
          <pc:sldMk cId="3005349361" sldId="267"/>
        </pc:sldMkLst>
      </pc:sldChg>
      <pc:sldChg chg="addSp modSp mod">
        <pc:chgData name="Anca Pordea (staff)" userId="04217c9e-4602-4538-8d25-5638668eb9f5" providerId="ADAL" clId="{192F7D91-0ACB-412C-8994-807677E4477E}" dt="2023-12-19T19:16:03.391" v="12" actId="1036"/>
        <pc:sldMkLst>
          <pc:docMk/>
          <pc:sldMk cId="290462980" sldId="268"/>
        </pc:sldMkLst>
        <pc:spChg chg="add mod">
          <ac:chgData name="Anca Pordea (staff)" userId="04217c9e-4602-4538-8d25-5638668eb9f5" providerId="ADAL" clId="{192F7D91-0ACB-412C-8994-807677E4477E}" dt="2023-12-19T19:16:00.408" v="5" actId="14100"/>
          <ac:spMkLst>
            <pc:docMk/>
            <pc:sldMk cId="290462980" sldId="268"/>
            <ac:spMk id="3" creationId="{628E7EAD-AC2C-BA44-7250-A1F6E3091BD3}"/>
          </ac:spMkLst>
        </pc:spChg>
        <pc:graphicFrameChg chg="mod">
          <ac:chgData name="Anca Pordea (staff)" userId="04217c9e-4602-4538-8d25-5638668eb9f5" providerId="ADAL" clId="{192F7D91-0ACB-412C-8994-807677E4477E}" dt="2023-12-19T19:16:03.391" v="12" actId="1036"/>
          <ac:graphicFrameMkLst>
            <pc:docMk/>
            <pc:sldMk cId="290462980" sldId="268"/>
            <ac:graphicFrameMk id="6" creationId="{04B52AB2-FC44-C2E0-FA18-6A4F1D9F67E5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86DAC8-0F5C-40C4-9048-03E5F0338584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82B562-5671-4D39-9920-23E3852B6F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84031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7 Table. Frequency of contacts between the substrate and LcpK30 calculated during 100 ns MD simulations of 10 docking poses obtained from </a:t>
            </a:r>
            <a:r>
              <a:rPr lang="en-US" b="1" dirty="0" err="1"/>
              <a:t>ChemScore</a:t>
            </a:r>
            <a:r>
              <a:rPr lang="en-US" b="1" dirty="0"/>
              <a:t> fitness function</a:t>
            </a:r>
            <a:r>
              <a:rPr lang="en-US" dirty="0"/>
              <a:t>. Docking solutions were initially ranked based on the fitness score from highest to lowest. A cut-off of 5 Å was used and only contacts with total fraction more than 4.5 % are listed. Ext = extended conformation; Fold = folded conformation. </a:t>
            </a:r>
            <a:endParaRPr lang="en-MY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82B562-5671-4D39-9920-23E3852B6FD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85904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839CC-2F4F-9676-481C-A8C6BD60D3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B78B30-6C9E-9383-5A22-347469CEE2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CF3B91-4E34-CF19-361A-C8592EC86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C2D85-0EFD-F1E1-E255-D409A42D7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04A4AE-7753-7C00-721D-98EB26BA0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3397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1454C2-05D2-40B2-C98F-42188163E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A9FF01-EC14-452C-3CE0-F69E790709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EE166A-724F-0654-6132-EB6D136E6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5865FF-D369-A9FB-BE86-F396D4D2E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AD3664-4433-2CAF-0724-6D43A5EDC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9828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E88ECF-540D-9D8B-AA3D-0BFBCF95FB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DF5B47-A83B-3433-E305-0968F562A8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44D5D9-63A2-6610-C517-62DD48C0F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5B9AA1-97FE-DF9C-A3CB-5C208B826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75377F-1DCC-3F4C-1493-4EB469A4B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912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B743F2-CAC8-CCE5-22CC-8CCBCD2DF0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F9F779-89A1-544A-951D-A892F041EA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29A8DE-F0E3-F7D3-F0D4-FF0540892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BD0439-C25F-AD3D-FB4B-F9C044F03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C2FB56-DEEF-B1EC-BB2B-6B06B28E5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6120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BD81C7-B648-ECBB-EB5A-190AA87800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B8D037-CFF8-3CAE-B59F-42FF4DE911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D3928D-3201-D840-2A36-11982338F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EDBB0-1CBA-B1A9-36C6-CD364295E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EEA93A-115B-D044-5063-CCA7ACB1C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7324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8D1655-2CC5-8A36-679E-B66A3C818B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E9BB75-23E1-8048-21F0-8291ADA465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1A3F4A-1C5D-7B02-8B21-9555A35726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4E35E8-F04A-5333-D410-00E243298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A075AA-CC28-DF86-0F94-4D99C3AC99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BFF910-1687-8D7A-1E60-FB4E3700E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8942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86B51B-A49C-DB81-129D-770B7B81E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3D9DB3-E956-030A-1DF5-3FB9D03B44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D2E3A9-FCD4-5AFE-85C4-F8F4DDA715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A0BCEB-5EF9-7EE9-599C-6B94A4674A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2392368-689C-6BF0-C77F-0FC8D9730B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521DC13-1D6B-88D7-E33B-841299F68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61249E9-F2D9-4CE8-E6E4-69784C9156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5DCCF0F-0559-9B9A-9D3B-F937169A29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2448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BE970B-DA53-0A74-ECA7-73762CEB39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514DDAA-CD12-6445-0D2D-6426A9B8D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E4ED273-A5E0-4AA0-9FB8-376853020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24533B-EB08-5EF6-12E6-A61B91BB1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3049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CCA8A7-6C30-3E41-FDA4-305B64DA93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98FDF7-8B82-C3B9-B1D3-F8A0D4019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6B7E57B-3FA1-1E79-D470-B0A6445580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1219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6032A7-73AA-3738-F12D-A9F0F15F7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F9093D-A355-AE1D-2978-2A67002740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DE4AE4-E591-8AD3-0D49-79DAC0AD2F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8C028F-B9A0-811D-83B5-8780FC264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1EC2C9-44C6-5DDA-05D2-3CBF197BF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4A6038-8120-45EA-B5FE-EDC53B703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9556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9EFBDF-8326-737F-3DE1-8A0F176EF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75A8341-5D99-22B5-5588-0F213643C6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1F0F35-0A56-8640-3CB0-13C12B4769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94D0A3-D271-0D2E-F074-B7ACC0632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72C26D-735A-EDE8-811B-C6F37C007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1E86F7-F0E0-0A6F-02B3-303AB6C43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2666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F7FA97-498A-322A-7FC1-14CEFA006F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C761D6-4CC6-BD9F-31FF-4C66405D9E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92A81E-83E9-C733-B6FA-CCC1763CC7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D18AAE-C4F2-C908-CFD8-36D483C0CB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562CB5-FAC8-96AE-9FC4-FD1DF197A0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404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04B52AB2-FC44-C2E0-FA18-6A4F1D9F67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4342019"/>
              </p:ext>
            </p:extLst>
          </p:nvPr>
        </p:nvGraphicFramePr>
        <p:xfrm>
          <a:off x="2408827" y="607362"/>
          <a:ext cx="7156997" cy="612893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13397">
                  <a:extLst>
                    <a:ext uri="{9D8B030D-6E8A-4147-A177-3AD203B41FA5}">
                      <a16:colId xmlns:a16="http://schemas.microsoft.com/office/drawing/2014/main" val="1322113572"/>
                    </a:ext>
                  </a:extLst>
                </a:gridCol>
                <a:gridCol w="431165">
                  <a:extLst>
                    <a:ext uri="{9D8B030D-6E8A-4147-A177-3AD203B41FA5}">
                      <a16:colId xmlns:a16="http://schemas.microsoft.com/office/drawing/2014/main" val="1560688096"/>
                    </a:ext>
                  </a:extLst>
                </a:gridCol>
                <a:gridCol w="580390">
                  <a:extLst>
                    <a:ext uri="{9D8B030D-6E8A-4147-A177-3AD203B41FA5}">
                      <a16:colId xmlns:a16="http://schemas.microsoft.com/office/drawing/2014/main" val="3765002179"/>
                    </a:ext>
                  </a:extLst>
                </a:gridCol>
                <a:gridCol w="580390">
                  <a:extLst>
                    <a:ext uri="{9D8B030D-6E8A-4147-A177-3AD203B41FA5}">
                      <a16:colId xmlns:a16="http://schemas.microsoft.com/office/drawing/2014/main" val="3823683571"/>
                    </a:ext>
                  </a:extLst>
                </a:gridCol>
                <a:gridCol w="580390">
                  <a:extLst>
                    <a:ext uri="{9D8B030D-6E8A-4147-A177-3AD203B41FA5}">
                      <a16:colId xmlns:a16="http://schemas.microsoft.com/office/drawing/2014/main" val="746055763"/>
                    </a:ext>
                  </a:extLst>
                </a:gridCol>
                <a:gridCol w="580390">
                  <a:extLst>
                    <a:ext uri="{9D8B030D-6E8A-4147-A177-3AD203B41FA5}">
                      <a16:colId xmlns:a16="http://schemas.microsoft.com/office/drawing/2014/main" val="2449615021"/>
                    </a:ext>
                  </a:extLst>
                </a:gridCol>
                <a:gridCol w="580390">
                  <a:extLst>
                    <a:ext uri="{9D8B030D-6E8A-4147-A177-3AD203B41FA5}">
                      <a16:colId xmlns:a16="http://schemas.microsoft.com/office/drawing/2014/main" val="4080783323"/>
                    </a:ext>
                  </a:extLst>
                </a:gridCol>
                <a:gridCol w="580390">
                  <a:extLst>
                    <a:ext uri="{9D8B030D-6E8A-4147-A177-3AD203B41FA5}">
                      <a16:colId xmlns:a16="http://schemas.microsoft.com/office/drawing/2014/main" val="1848156031"/>
                    </a:ext>
                  </a:extLst>
                </a:gridCol>
                <a:gridCol w="580390">
                  <a:extLst>
                    <a:ext uri="{9D8B030D-6E8A-4147-A177-3AD203B41FA5}">
                      <a16:colId xmlns:a16="http://schemas.microsoft.com/office/drawing/2014/main" val="1867436110"/>
                    </a:ext>
                  </a:extLst>
                </a:gridCol>
                <a:gridCol w="431165">
                  <a:extLst>
                    <a:ext uri="{9D8B030D-6E8A-4147-A177-3AD203B41FA5}">
                      <a16:colId xmlns:a16="http://schemas.microsoft.com/office/drawing/2014/main" val="2588672786"/>
                    </a:ext>
                  </a:extLst>
                </a:gridCol>
                <a:gridCol w="1018540">
                  <a:extLst>
                    <a:ext uri="{9D8B030D-6E8A-4147-A177-3AD203B41FA5}">
                      <a16:colId xmlns:a16="http://schemas.microsoft.com/office/drawing/2014/main" val="297687869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Rank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1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2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3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4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5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6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7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8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9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0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52772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Ligand conformation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olded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tended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tended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tended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tended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tended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tended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tended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olded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tended/Folded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84337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Residues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10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otal fraction (%)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41801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yr134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76093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er138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.29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67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.51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326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ly139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21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11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80556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er142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17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.84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81051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le145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7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54844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lu148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03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.06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22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76426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Val152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.82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99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456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la159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54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78720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sp163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8.24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51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36454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rg164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.05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8.75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.27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.08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08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65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02962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ys167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2.33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.89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.79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54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.38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.45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.67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.99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.3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635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r168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.18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34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.82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.95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38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.18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77425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la169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81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65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23079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rg170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.17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46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.39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.83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8.42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54536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eu171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3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.93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35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54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78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.2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.44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.5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69445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ly172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.32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85584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sp174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24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.87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98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19734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le175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83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09733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er186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78937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r188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.23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.72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37327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r230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02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.92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38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93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72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21334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rp231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91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68163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er233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.72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42155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eu234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42866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rp261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.54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66042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lu392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1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42953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ly393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39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41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62362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le396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.61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36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17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.39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.64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32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.44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.67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42033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le398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89343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sp399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87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48492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em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9.64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0.2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3.09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7.38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3.05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.7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4.37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3.78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1.35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2.84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20314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MY" sz="1100" dirty="0"/>
                        <a:t>O</a:t>
                      </a:r>
                      <a:r>
                        <a:rPr lang="en-MY" sz="1100" baseline="-25000" dirty="0"/>
                        <a:t>2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.98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86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63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.4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.87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4</a:t>
                      </a: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668622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628E7EAD-AC2C-BA44-7250-A1F6E3091BD3}"/>
              </a:ext>
            </a:extLst>
          </p:cNvPr>
          <p:cNvSpPr txBox="1"/>
          <p:nvPr/>
        </p:nvSpPr>
        <p:spPr>
          <a:xfrm>
            <a:off x="166479" y="0"/>
            <a:ext cx="11591511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7 Table. Frequency of contacts between the substrate and LcpK30 calculated during 100 ns MD simulations of 10 docking poses obtained from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hemScore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fitness functio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Docking solutions were initially ranked based on the fitness score from highest to lowest. A cut-off of 5 Å was used and only contacts with total fraction more than 4.5 % are listed. Ext = extended conformation; Fold = folded conformation. </a:t>
            </a:r>
            <a:endParaRPr lang="en-MY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462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c1e910d-4918-42f1-af2c-ed1101d63abc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7573F99DE79145B2C4B20841E12603" ma:contentTypeVersion="17" ma:contentTypeDescription="Create a new document." ma:contentTypeScope="" ma:versionID="75a924c6fce2bfbfdafe8aa5030a8127">
  <xsd:schema xmlns:xsd="http://www.w3.org/2001/XMLSchema" xmlns:xs="http://www.w3.org/2001/XMLSchema" xmlns:p="http://schemas.microsoft.com/office/2006/metadata/properties" xmlns:ns3="0c1e910d-4918-42f1-af2c-ed1101d63abc" xmlns:ns4="786e620f-b1da-4f59-878c-ef7546d25bf1" targetNamespace="http://schemas.microsoft.com/office/2006/metadata/properties" ma:root="true" ma:fieldsID="84345ca33903240b6bb317a7195b494d" ns3:_="" ns4:_="">
    <xsd:import namespace="0c1e910d-4918-42f1-af2c-ed1101d63abc"/>
    <xsd:import namespace="786e620f-b1da-4f59-878c-ef7546d25bf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c1e910d-4918-42f1-af2c-ed1101d63ab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description="" ma:internalName="MediaServiceAutoTags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3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6e620f-b1da-4f59-878c-ef7546d25bf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B9F79417-562A-4DE7-A712-D28018C4F2AC}">
  <ds:schemaRefs>
    <ds:schemaRef ds:uri="http://schemas.microsoft.com/office/2006/documentManagement/types"/>
    <ds:schemaRef ds:uri="0c1e910d-4918-42f1-af2c-ed1101d63abc"/>
    <ds:schemaRef ds:uri="786e620f-b1da-4f59-878c-ef7546d25bf1"/>
    <ds:schemaRef ds:uri="http://purl.org/dc/terms/"/>
    <ds:schemaRef ds:uri="http://www.w3.org/XML/1998/namespace"/>
    <ds:schemaRef ds:uri="http://purl.org/dc/elements/1.1/"/>
    <ds:schemaRef ds:uri="http://schemas.openxmlformats.org/package/2006/metadata/core-properties"/>
    <ds:schemaRef ds:uri="http://schemas.microsoft.com/office/2006/metadata/properties"/>
    <ds:schemaRef ds:uri="http://schemas.microsoft.com/office/infopath/2007/PartnerControl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836657D4-EBCE-4BEE-8B50-6ABE2577DC9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c1e910d-4918-42f1-af2c-ed1101d63abc"/>
    <ds:schemaRef ds:uri="786e620f-b1da-4f59-878c-ef7546d25bf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58BC3993-CD11-46D5-AFD3-539F9D1D026D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418</TotalTime>
  <Words>526</Words>
  <Application>Microsoft Office PowerPoint</Application>
  <PresentationFormat>Widescreen</PresentationFormat>
  <Paragraphs>37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o Hanzevacki (staff)</dc:creator>
  <cp:lastModifiedBy>Anca Pordea (staff)</cp:lastModifiedBy>
  <cp:revision>366</cp:revision>
  <dcterms:created xsi:type="dcterms:W3CDTF">2022-09-23T18:06:25Z</dcterms:created>
  <dcterms:modified xsi:type="dcterms:W3CDTF">2023-12-19T19:16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7573F99DE79145B2C4B20841E12603</vt:lpwstr>
  </property>
</Properties>
</file>